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422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242231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1275408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135492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456276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94532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604512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1425175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0626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64853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439186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99579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4B46C-B44B-4837-9DCD-924C840925A6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9F249-D1C6-4316-9366-08982D296CC1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76322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7432" y="76470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93844" y="37890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pic>
        <p:nvPicPr>
          <p:cNvPr id="6" name="Picture 4" descr="E:\argB,nicB,adeA\Picture5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15616" y="3933056"/>
            <a:ext cx="4608512" cy="269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668344" y="332656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. Fig 3</a:t>
            </a:r>
            <a:endParaRPr lang="en-GB" dirty="0"/>
          </a:p>
        </p:txBody>
      </p:sp>
      <p:pic>
        <p:nvPicPr>
          <p:cNvPr id="7" name="Picture 2" descr="E:\argB,nicB,adeA\argB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15616" y="809094"/>
            <a:ext cx="5760640" cy="26992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5724128" y="5085184"/>
            <a:ext cx="3419872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rticle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title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et of isogenic auxotrophic strains for constructing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ltipl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gen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deletio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tants and parasexual crossings in Aspergillus niger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journal name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rchive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f Microbiology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uthor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names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ing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iu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ark Arentshorst, Felix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eelinger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Arthur F.J. Ram*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ean Paul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uedraogo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ffiliation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olecular Microbiology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nd Biotechnology, Leiden University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ylviusweg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72, 2333 BE Leiden, the Netherlands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corresponding author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.f.j.ram@biology.leidenuniv.nl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47433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77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eit Leid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, A.F.J.</dc:creator>
  <cp:lastModifiedBy>Arthur Ram</cp:lastModifiedBy>
  <cp:revision>5</cp:revision>
  <dcterms:created xsi:type="dcterms:W3CDTF">2016-03-10T13:24:06Z</dcterms:created>
  <dcterms:modified xsi:type="dcterms:W3CDTF">2016-04-27T10:57:23Z</dcterms:modified>
</cp:coreProperties>
</file>